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81" d="100"/>
          <a:sy n="81" d="100"/>
        </p:scale>
        <p:origin x="725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4B6F86-E59B-498D-9D4B-BA10CC07A4E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5919B2-E0A8-42EE-8000-601B4CDCB2E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9E189BB-8193-47E7-820A-86D1CE896F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0A3905-4B1F-49AE-B8D8-B49745F7F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02CFE3C-83AD-4F59-9398-9BF93040A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535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6DF30B-3B6B-4E64-B4E2-3BCF2222BF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B32385-B89C-411C-9A4E-EAA6CC56D5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A34BAB-7897-4395-BAFE-16609CC9A2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254F26-72EE-4A87-91B4-1CFD60C0F4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334B59-A0DF-4131-BE7A-3AE221A622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3214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EF44CFF-5C5C-4782-92E9-72EED57CB5E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B70CE6E-2181-478A-8589-8FE0CE3CBF9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A53EBC-C6DE-4000-B6C9-7BE9F23A5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B30893-756A-4797-825D-B1AC475004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255E5B-5B65-40F6-922D-A87F18A7C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5509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03E94A-8BB3-450D-AB00-B22C62C2CA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827A2D-64C4-4350-AB71-160E3E4C74D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FC1C0-801B-4280-A767-66A103C3AE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9672D5-1D2A-43B7-BB53-201003E873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0A4E7C-E90B-46D2-8B52-11EFEE811C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4621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A5D3B-4AAD-40CF-ABE9-47E3E00F7D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97BC8-2BD0-47CF-962E-DFA690539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F7826-DFC7-45F7-83BA-492BBD8BC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A6E593-8466-4FAE-A871-B5FE2F680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5C77A69-EF5C-48BA-8CD5-DAA6900806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1675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A2B939-9EE6-475A-B1C6-B7A6F92DB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E709B4E-24FD-4793-BF76-4DC7005A306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4948E18-FF47-455B-98B8-272B164F0D4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0895B6-1E04-40B3-BF82-487A1A040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F94FB8-1E92-4FA3-8FC3-4171D23123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660985-CF57-4A90-9860-4E7445AA00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482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F96CA2-C740-4E9B-A556-5ADEF4452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5919ABE-B54D-4BA6-940B-6F41B6B70A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6115960-2455-425B-B70C-7C8F20483C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56F2A0-CA32-4E8F-8EC7-F224649FED4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2907391-2F78-4242-B8BF-E51B41B6B9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F12C9D8-DA34-43D8-A8FE-195A61E673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4F2500B-D1CC-492A-B33F-6A5BE529F5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7E5B675-406F-41CB-B730-EA9B83F27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3987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7ACC93-9CFC-43D4-86DE-7423A81400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788462-D85C-4378-9707-E286D616B8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3BA981E-78DC-4B3A-929C-631C2735B2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2DE450-89B7-46D4-9004-924D52FEE1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6070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B0AB7A3-A817-4AC2-A2C7-1B9C0A24F2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2756957-5E14-47EF-B5DA-A187BE681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3180329-61BC-415C-9CBD-B27BB83572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1284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C95FEC-A4E5-48E3-A519-BABB897C17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4AC572-4A5D-4F6F-9E7E-00CADC3CF69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6F0457-642B-493A-A3CE-986239E8CC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F68A10-FEBD-40E9-9CAC-383E46C74C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DEECE2-45A5-4960-95DC-C14EAB0C41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3A619E-A2F5-4AE7-A0D6-EE0EAFF5B6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1926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A92DC1-7967-44ED-8213-375352EF39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A8FB80F-461A-43EB-8707-D257E0086E1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BB39ABC-F1EB-4284-B693-36DA1755AA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F43689-27C0-4AF7-B9F6-212D676E58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E924106-17CB-4DFC-8DC8-3A2411AAA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4F7675C-7A8D-41DD-8534-596890BEBA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13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7E9C29-4D03-43DF-81F6-751BC66E90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03D461-1626-42AB-9CAF-392199C015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AB6239-E801-4089-8876-00A6CCFB7AC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BA276B-2F51-4B1B-871A-D28520C495CA}" type="datetimeFigureOut">
              <a:rPr lang="en-US" smtClean="0"/>
              <a:t>6/6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E2E074-67DB-4C96-A0C7-02D70E2AB1E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D50EC8-C483-42D3-BA66-2A21DE4F0E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02AF58-917F-40F6-B8FE-34881E531F3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9908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A screenshot of a cell phone&#10;&#10;Description automatically generated">
            <a:extLst>
              <a:ext uri="{FF2B5EF4-FFF2-40B4-BE49-F238E27FC236}">
                <a16:creationId xmlns:a16="http://schemas.microsoft.com/office/drawing/2014/main" id="{F9E26344-0663-4316-AB87-3E59641797C8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7472" y="1280160"/>
            <a:ext cx="4351338" cy="4351338"/>
          </a:xfrm>
        </p:spPr>
      </p:pic>
      <p:sp>
        <p:nvSpPr>
          <p:cNvPr id="2" name="Title 1">
            <a:extLst>
              <a:ext uri="{FF2B5EF4-FFF2-40B4-BE49-F238E27FC236}">
                <a16:creationId xmlns:a16="http://schemas.microsoft.com/office/drawing/2014/main" id="{7F0B6519-796C-42B6-BA1B-6D0413AFBC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88952" cy="914400"/>
          </a:xfrm>
        </p:spPr>
        <p:txBody>
          <a:bodyPr>
            <a:norm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mparison of the performances of different DNA methylation data normalization and preprocessing methods: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rrelation between technical replicates; (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robe variance between technical replicates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B2BB0A6D-449F-4B37-9B37-6333695ABF76}"/>
              </a:ext>
            </a:extLst>
          </p:cNvPr>
          <p:cNvSpPr txBox="1"/>
          <p:nvPr/>
        </p:nvSpPr>
        <p:spPr>
          <a:xfrm>
            <a:off x="284104" y="1125604"/>
            <a:ext cx="4539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4AB8C0CC-3A49-40F0-829B-A7DD7B1F72E4}"/>
              </a:ext>
            </a:extLst>
          </p:cNvPr>
          <p:cNvSpPr txBox="1"/>
          <p:nvPr/>
        </p:nvSpPr>
        <p:spPr>
          <a:xfrm>
            <a:off x="6105784" y="1122556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72CF354-CA57-4E01-857B-858B8E4A085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951216" y="1280160"/>
            <a:ext cx="4589755" cy="44193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49513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4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Figure S1. Comparison of the performances of different DNA methylation data normalization and preprocessing methods: (a) correlation between technical replicates; (b) probe variance between technical replicates.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juddin, Salman (NIH/NIA/IRP) [F]</dc:creator>
  <cp:lastModifiedBy>Kumaraswamy Naidu Chitrala</cp:lastModifiedBy>
  <cp:revision>16</cp:revision>
  <cp:lastPrinted>2019-06-06T15:06:35Z</cp:lastPrinted>
  <dcterms:created xsi:type="dcterms:W3CDTF">2018-08-05T17:31:02Z</dcterms:created>
  <dcterms:modified xsi:type="dcterms:W3CDTF">2019-06-06T21:21:55Z</dcterms:modified>
</cp:coreProperties>
</file>